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1740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361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040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7786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539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466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339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819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7024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02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9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9077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31F8E-5EA9-4607-A428-53E369CCEEBE}" type="datetimeFigureOut">
              <a:rPr kumimoji="1" lang="ja-JP" altLang="en-US" smtClean="0"/>
              <a:t>2023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9FD52-83C2-4BC9-B35F-2E0F05368A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8958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屋内, 座る, テーブル, 横たわる が含まれている画像&#10;&#10;自動的に生成された説明">
            <a:extLst>
              <a:ext uri="{FF2B5EF4-FFF2-40B4-BE49-F238E27FC236}">
                <a16:creationId xmlns:a16="http://schemas.microsoft.com/office/drawing/2014/main" id="{C24F70D0-848B-488F-A64D-F4E7B2759B2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047438" y="1807696"/>
            <a:ext cx="1700811" cy="1357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図 14" descr="小さい, テーブル, 座る, 電話 が含まれている画像&#10;&#10;自動的に生成された説明">
            <a:extLst>
              <a:ext uri="{FF2B5EF4-FFF2-40B4-BE49-F238E27FC236}">
                <a16:creationId xmlns:a16="http://schemas.microsoft.com/office/drawing/2014/main" id="{156AC97E-7B48-4936-B944-2E9E31C9D15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93386" y="224422"/>
            <a:ext cx="1700762" cy="13578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 descr="座る, 横たわる, テーブル, 立つ が含まれている画像&#10;&#10;自動的に生成された説明">
            <a:extLst>
              <a:ext uri="{FF2B5EF4-FFF2-40B4-BE49-F238E27FC236}">
                <a16:creationId xmlns:a16="http://schemas.microsoft.com/office/drawing/2014/main" id="{9AABA6F1-4022-425D-BB3A-3EBBDF2FFCC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93337" y="1807771"/>
            <a:ext cx="1700811" cy="13578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図 36" descr="横たわる, 座る, テーブル, ペア が含まれている画像&#10;&#10;自動的に生成された説明">
            <a:extLst>
              <a:ext uri="{FF2B5EF4-FFF2-40B4-BE49-F238E27FC236}">
                <a16:creationId xmlns:a16="http://schemas.microsoft.com/office/drawing/2014/main" id="{C19C55A5-54D3-40CD-9463-96D08152043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159991" y="1807770"/>
            <a:ext cx="1721603" cy="135786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64CD1A74-2496-42BD-A17B-AF0622E9FB48}"/>
              </a:ext>
            </a:extLst>
          </p:cNvPr>
          <p:cNvCxnSpPr>
            <a:cxnSpLocks/>
          </p:cNvCxnSpPr>
          <p:nvPr/>
        </p:nvCxnSpPr>
        <p:spPr>
          <a:xfrm>
            <a:off x="433577" y="2486663"/>
            <a:ext cx="0" cy="576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4B0AB4FC-224B-4F13-A224-8D849F5381C7}"/>
              </a:ext>
            </a:extLst>
          </p:cNvPr>
          <p:cNvCxnSpPr>
            <a:cxnSpLocks/>
          </p:cNvCxnSpPr>
          <p:nvPr/>
        </p:nvCxnSpPr>
        <p:spPr>
          <a:xfrm>
            <a:off x="2325877" y="2486663"/>
            <a:ext cx="0" cy="576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925A5EBC-F77A-4EA4-9FD4-6371190AEFCE}"/>
              </a:ext>
            </a:extLst>
          </p:cNvPr>
          <p:cNvCxnSpPr>
            <a:cxnSpLocks/>
          </p:cNvCxnSpPr>
          <p:nvPr/>
        </p:nvCxnSpPr>
        <p:spPr>
          <a:xfrm>
            <a:off x="4205477" y="2486663"/>
            <a:ext cx="0" cy="576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FF098D67-2E7B-4EA6-8A48-381A09902A15}"/>
              </a:ext>
            </a:extLst>
          </p:cNvPr>
          <p:cNvCxnSpPr>
            <a:cxnSpLocks/>
          </p:cNvCxnSpPr>
          <p:nvPr/>
        </p:nvCxnSpPr>
        <p:spPr>
          <a:xfrm>
            <a:off x="433577" y="941470"/>
            <a:ext cx="0" cy="576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C839863-CB89-47BF-BD28-F841C51393FE}"/>
              </a:ext>
            </a:extLst>
          </p:cNvPr>
          <p:cNvSpPr txBox="1"/>
          <p:nvPr/>
        </p:nvSpPr>
        <p:spPr>
          <a:xfrm>
            <a:off x="0" y="3461022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ified view of anthers in Kishu, 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46, Satsuma mandarin (cv. 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se), and ‘Kiyomi’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sterile varieties/selected strains,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46, Satsuma mandarin (cv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se), and ‘Kiyomi’. The anthers in Kishu mandarin are shown as male fertile controls. These anthers were collected after full bloom during anthesis. Bar = 2 mm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6BFF4FF-392F-446F-AF18-DF62C2B85516}"/>
              </a:ext>
            </a:extLst>
          </p:cNvPr>
          <p:cNvSpPr txBox="1"/>
          <p:nvPr/>
        </p:nvSpPr>
        <p:spPr>
          <a:xfrm>
            <a:off x="559616" y="1517470"/>
            <a:ext cx="1265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shu</a:t>
            </a:r>
            <a:r>
              <a: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darin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8C0DA39-86EF-4899-BB69-E01B4B0B6E4B}"/>
              </a:ext>
            </a:extLst>
          </p:cNvPr>
          <p:cNvSpPr txBox="1"/>
          <p:nvPr/>
        </p:nvSpPr>
        <p:spPr>
          <a:xfrm>
            <a:off x="653729" y="3157607"/>
            <a:ext cx="1085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46</a:t>
            </a:r>
            <a:endParaRPr kumimoji="1" lang="ja-JP" altLang="en-US" sz="12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7B385C8-DDC8-4CEA-91ED-57AB006C8263}"/>
              </a:ext>
            </a:extLst>
          </p:cNvPr>
          <p:cNvSpPr txBox="1"/>
          <p:nvPr/>
        </p:nvSpPr>
        <p:spPr>
          <a:xfrm>
            <a:off x="2354541" y="3157607"/>
            <a:ext cx="1473480" cy="356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tsuma mandarin </a:t>
            </a:r>
          </a:p>
          <a:p>
            <a:pPr>
              <a:lnSpc>
                <a:spcPts val="1000"/>
              </a:lnSpc>
            </a:pP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v. </a:t>
            </a:r>
            <a:r>
              <a:rPr kumimoji="1"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itsu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se) </a:t>
            </a:r>
            <a:endParaRPr kumimoji="1" lang="ja-JP" altLang="en-US" sz="120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E123468-2CDA-4321-BBFC-2CED122D71D9}"/>
              </a:ext>
            </a:extLst>
          </p:cNvPr>
          <p:cNvSpPr txBox="1"/>
          <p:nvPr/>
        </p:nvSpPr>
        <p:spPr>
          <a:xfrm>
            <a:off x="4648200" y="3157607"/>
            <a:ext cx="7780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yomi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873135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7</TotalTime>
  <Words>90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新悟　後藤</dc:creator>
  <cp:lastModifiedBy>Shingo Goto</cp:lastModifiedBy>
  <cp:revision>23</cp:revision>
  <dcterms:created xsi:type="dcterms:W3CDTF">2022-09-30T02:48:07Z</dcterms:created>
  <dcterms:modified xsi:type="dcterms:W3CDTF">2023-02-10T09:49:04Z</dcterms:modified>
</cp:coreProperties>
</file>